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34" autoAdjust="0"/>
    <p:restoredTop sz="94660"/>
  </p:normalViewPr>
  <p:slideViewPr>
    <p:cSldViewPr snapToGrid="0">
      <p:cViewPr varScale="1">
        <p:scale>
          <a:sx n="60" d="100"/>
          <a:sy n="60" d="100"/>
        </p:scale>
        <p:origin x="129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0407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0468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01218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59705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88384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18298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2549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86577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25297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3233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42808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13833C-9357-4830-B005-90A980F793B2}" type="datetimeFigureOut">
              <a:rPr kumimoji="1" lang="ja-JP" altLang="en-US" smtClean="0"/>
              <a:t>2019/9/3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13D71-69BC-4A89-A6BF-86B7B45BDE4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0660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38653" y="1765848"/>
            <a:ext cx="7480428" cy="3688655"/>
          </a:xfrm>
          <a:prstGeom prst="rect">
            <a:avLst/>
          </a:prstGeom>
        </p:spPr>
      </p:pic>
      <p:sp>
        <p:nvSpPr>
          <p:cNvPr id="4" name="テキスト ボックス 3"/>
          <p:cNvSpPr txBox="1"/>
          <p:nvPr/>
        </p:nvSpPr>
        <p:spPr>
          <a:xfrm>
            <a:off x="838653" y="839972"/>
            <a:ext cx="761291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3 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in appearance when a mixture of betamethasone butyrate propionate and betamethasone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valerate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cream </a:t>
            </a:r>
            <a:r>
              <a:rPr kumimoji="1" lang="en-US" altLang="ja-JP" sz="1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ormulations 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moisturizer is centrifuged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102641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3</TotalTime>
  <Words>22</Words>
  <Application>Microsoft Office PowerPoint</Application>
  <PresentationFormat>画面に合わせる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游ゴシック</vt:lpstr>
      <vt:lpstr>游ゴシック Light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山本　佳久</dc:creator>
  <cp:lastModifiedBy>山本　佳久</cp:lastModifiedBy>
  <cp:revision>6</cp:revision>
  <dcterms:created xsi:type="dcterms:W3CDTF">2019-09-28T05:48:37Z</dcterms:created>
  <dcterms:modified xsi:type="dcterms:W3CDTF">2019-09-30T07:02:11Z</dcterms:modified>
</cp:coreProperties>
</file>